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2801600" cy="96012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AE2F44-D88A-4BBD-8192-9531F1EDF9D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39720" y="383760"/>
            <a:ext cx="11522160" cy="160020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ctr">
            <a:noAutofit/>
          </a:bodyPr>
          <a:p>
            <a:pPr indent="0" algn="ctr"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39720" y="2239920"/>
            <a:ext cx="11522160" cy="30229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39720" y="5550480"/>
            <a:ext cx="11522160" cy="30229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D9D593-B863-4D1E-ABBC-8D42E7076E2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39720" y="383760"/>
            <a:ext cx="11522160" cy="160020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ctr">
            <a:noAutofit/>
          </a:bodyPr>
          <a:p>
            <a:pPr indent="0" algn="ctr"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39720" y="2239920"/>
            <a:ext cx="5622480" cy="30229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543720" y="2239920"/>
            <a:ext cx="5622480" cy="30229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39720" y="5550480"/>
            <a:ext cx="5622480" cy="30229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543720" y="5550480"/>
            <a:ext cx="5622480" cy="30229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201703-29C9-48C8-A9AF-1D7B7A37305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39720" y="383760"/>
            <a:ext cx="11522160" cy="160020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ctr">
            <a:noAutofit/>
          </a:bodyPr>
          <a:p>
            <a:pPr indent="0" algn="ctr"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39720" y="2239920"/>
            <a:ext cx="3709800" cy="30229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535280" y="2239920"/>
            <a:ext cx="3709800" cy="30229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8431200" y="2239920"/>
            <a:ext cx="3709800" cy="30229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39720" y="5550480"/>
            <a:ext cx="3709800" cy="30229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535280" y="5550480"/>
            <a:ext cx="3709800" cy="30229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8431200" y="5550480"/>
            <a:ext cx="3709800" cy="30229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F3EBE7-BFE0-4044-A948-AC1CDE207CC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39720" y="383760"/>
            <a:ext cx="11522160" cy="160020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ctr">
            <a:noAutofit/>
          </a:bodyPr>
          <a:p>
            <a:pPr indent="0" algn="ctr"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39720" y="2239920"/>
            <a:ext cx="11522160" cy="6337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1125"/>
              </a:spcBef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039972-DC3D-43EA-A682-15FA5EF6F6C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39720" y="383760"/>
            <a:ext cx="11522160" cy="160020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ctr">
            <a:noAutofit/>
          </a:bodyPr>
          <a:p>
            <a:pPr indent="0" algn="ctr"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39720" y="2239920"/>
            <a:ext cx="11522160" cy="633744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E7BF5B-7755-45F3-ACB4-868A5E4B48D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39720" y="383760"/>
            <a:ext cx="11522160" cy="160020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ctr">
            <a:noAutofit/>
          </a:bodyPr>
          <a:p>
            <a:pPr indent="0" algn="ctr"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39720" y="2239920"/>
            <a:ext cx="5622480" cy="633744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543720" y="2239920"/>
            <a:ext cx="5622480" cy="633744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F8B269-CD12-49C4-A86B-E4EB5A6D314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39720" y="383760"/>
            <a:ext cx="11522160" cy="160020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ctr">
            <a:noAutofit/>
          </a:bodyPr>
          <a:p>
            <a:pPr indent="0" algn="ctr"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036AAC-8DA7-4B8A-AE17-AAAC5BC4CB8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39720" y="383760"/>
            <a:ext cx="11522160" cy="7418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1125"/>
              </a:spcBef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9B5FEA-A051-4C9A-AED3-8ADBE0A8E8F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39720" y="383760"/>
            <a:ext cx="11522160" cy="160020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ctr">
            <a:noAutofit/>
          </a:bodyPr>
          <a:p>
            <a:pPr indent="0" algn="ctr"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39720" y="2239920"/>
            <a:ext cx="5622480" cy="30229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543720" y="2239920"/>
            <a:ext cx="5622480" cy="633744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39720" y="5550480"/>
            <a:ext cx="5622480" cy="30229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EE6B70-F402-40A2-BF68-CE1C07737D8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39720" y="383760"/>
            <a:ext cx="11522160" cy="160020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ctr">
            <a:noAutofit/>
          </a:bodyPr>
          <a:p>
            <a:pPr indent="0" algn="ctr"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39720" y="2239920"/>
            <a:ext cx="5622480" cy="633744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543720" y="2239920"/>
            <a:ext cx="5622480" cy="30229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543720" y="5550480"/>
            <a:ext cx="5622480" cy="30229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5F023D-2F4A-4AC1-9BC4-C15D650699D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39720" y="383760"/>
            <a:ext cx="11522160" cy="160020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ctr">
            <a:noAutofit/>
          </a:bodyPr>
          <a:p>
            <a:pPr indent="0" algn="ctr"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39720" y="2239920"/>
            <a:ext cx="5622480" cy="30229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543720" y="2239920"/>
            <a:ext cx="5622480" cy="30229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39720" y="5550480"/>
            <a:ext cx="11522160" cy="30229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845E24-01BD-4EC4-A464-8B363A55D69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39720" y="383760"/>
            <a:ext cx="11522160" cy="160020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ctr">
            <a:noAutofit/>
          </a:bodyPr>
          <a:p>
            <a:pPr indent="0" algn="ctr"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0" lang="en-US" sz="62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39720" y="2239920"/>
            <a:ext cx="11522160" cy="633744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marL="479520" indent="-479520">
              <a:spcBef>
                <a:spcPts val="1125"/>
              </a:spcBef>
              <a:buClr>
                <a:srgbClr val="000000"/>
              </a:buClr>
              <a:buFont typeface="Arial"/>
              <a:buChar char="•"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0" lang="en-US" sz="45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  <a:p>
            <a:pPr lvl="1" marL="1039680" indent="-399960">
              <a:spcBef>
                <a:spcPts val="1125"/>
              </a:spcBef>
              <a:buClr>
                <a:srgbClr val="000000"/>
              </a:buClr>
              <a:buFont typeface="Arial"/>
              <a:buChar char="–"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0" lang="en-US" sz="45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  <a:p>
            <a:pPr lvl="2" marL="1600200" indent="-318960">
              <a:spcBef>
                <a:spcPts val="1125"/>
              </a:spcBef>
              <a:buClr>
                <a:srgbClr val="000000"/>
              </a:buClr>
              <a:buFont typeface="Arial"/>
              <a:buChar char="•"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0" lang="en-US" sz="45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  <a:p>
            <a:pPr lvl="3" marL="2239920" indent="-318960">
              <a:spcBef>
                <a:spcPts val="1125"/>
              </a:spcBef>
              <a:buClr>
                <a:srgbClr val="000000"/>
              </a:buClr>
              <a:buFont typeface="Arial"/>
              <a:buChar char="–"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0" lang="en-US" sz="45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  <a:p>
            <a:pPr lvl="4" marL="2879640" indent="-318960">
              <a:spcBef>
                <a:spcPts val="1125"/>
              </a:spcBef>
              <a:buClr>
                <a:srgbClr val="000000"/>
              </a:buClr>
              <a:buFont typeface="Arial"/>
              <a:buChar char="»"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0" lang="en-US" sz="45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  <a:p>
            <a:pPr lvl="5" marL="2879640" indent="-318960">
              <a:spcBef>
                <a:spcPts val="1125"/>
              </a:spcBef>
              <a:buClr>
                <a:srgbClr val="000000"/>
              </a:buClr>
              <a:buFont typeface="Arial"/>
              <a:buChar char="»"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0" lang="en-US" sz="45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  <a:p>
            <a:pPr lvl="6" marL="2879640" indent="-318960">
              <a:spcBef>
                <a:spcPts val="1125"/>
              </a:spcBef>
              <a:buClr>
                <a:srgbClr val="000000"/>
              </a:buClr>
              <a:buFont typeface="Arial"/>
              <a:buChar char="»"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0" lang="en-US" sz="45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39360" y="8899560"/>
            <a:ext cx="2987640" cy="51120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  <a:defRPr b="0" lang="ja-JP" sz="17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fld id="{E26957A9-5F7A-4EAF-8CDD-CE6073570AE4}" type="datetime">
              <a:rPr b="0" lang="ja-JP" sz="1700" spc="-1" strike="noStrike">
                <a:solidFill>
                  <a:srgbClr val="898989"/>
                </a:solidFill>
                <a:latin typeface="Calibri"/>
              </a:rPr>
              <a:t>26/08/29</a:t>
            </a:fld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373640" y="8899560"/>
            <a:ext cx="4054320" cy="51120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ctr">
            <a:noAutofit/>
          </a:bodyPr>
          <a:p>
            <a:pPr indent="0"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9173880" y="8899560"/>
            <a:ext cx="2987640" cy="51120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  <a:defRPr b="0" lang="ja-JP" sz="17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fld id="{E919DBD5-B038-4299-AA46-7AD4957C676B}" type="slidenum">
              <a:rPr b="0" lang="ja-JP" sz="17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図 15" descr="6.eps"/>
          <p:cNvPicPr/>
          <p:nvPr/>
        </p:nvPicPr>
        <p:blipFill>
          <a:blip r:embed="rId1"/>
          <a:stretch/>
        </p:blipFill>
        <p:spPr>
          <a:xfrm>
            <a:off x="6902280" y="4821120"/>
            <a:ext cx="5295960" cy="4472280"/>
          </a:xfrm>
          <a:prstGeom prst="rect">
            <a:avLst/>
          </a:prstGeom>
          <a:ln w="0">
            <a:noFill/>
          </a:ln>
        </p:spPr>
      </p:pic>
      <p:pic>
        <p:nvPicPr>
          <p:cNvPr id="42" name="図 14" descr="4.eps"/>
          <p:cNvPicPr/>
          <p:nvPr/>
        </p:nvPicPr>
        <p:blipFill>
          <a:blip r:embed="rId2"/>
          <a:stretch/>
        </p:blipFill>
        <p:spPr>
          <a:xfrm>
            <a:off x="6902280" y="19080"/>
            <a:ext cx="5295960" cy="4470480"/>
          </a:xfrm>
          <a:prstGeom prst="rect">
            <a:avLst/>
          </a:prstGeom>
          <a:ln w="0">
            <a:noFill/>
          </a:ln>
        </p:spPr>
      </p:pic>
      <p:pic>
        <p:nvPicPr>
          <p:cNvPr id="43" name="図 13" descr="2.eps"/>
          <p:cNvPicPr/>
          <p:nvPr/>
        </p:nvPicPr>
        <p:blipFill>
          <a:blip r:embed="rId3"/>
          <a:stretch/>
        </p:blipFill>
        <p:spPr>
          <a:xfrm>
            <a:off x="477720" y="673200"/>
            <a:ext cx="6137280" cy="5182920"/>
          </a:xfrm>
          <a:prstGeom prst="rect">
            <a:avLst/>
          </a:prstGeom>
          <a:ln w="0">
            <a:noFill/>
          </a:ln>
        </p:spPr>
      </p:pic>
      <p:sp>
        <p:nvSpPr>
          <p:cNvPr id="44" name="Text Box 16"/>
          <p:cNvSpPr/>
          <p:nvPr/>
        </p:nvSpPr>
        <p:spPr>
          <a:xfrm>
            <a:off x="7122600" y="9177480"/>
            <a:ext cx="4495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</a:rPr>
              <a:t>Anti-differentiative edge network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13"/>
          <p:cNvSpPr/>
          <p:nvPr/>
        </p:nvSpPr>
        <p:spPr>
          <a:xfrm>
            <a:off x="6993360" y="4861080"/>
            <a:ext cx="6289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r>
              <a:rPr b="1" lang="en-US" sz="3600" spc="-1" strike="noStrike">
                <a:solidFill>
                  <a:srgbClr val="000000"/>
                </a:solidFill>
                <a:latin typeface="Calibri"/>
              </a:rPr>
              <a:t>S3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13"/>
          <p:cNvSpPr/>
          <p:nvPr/>
        </p:nvSpPr>
        <p:spPr>
          <a:xfrm>
            <a:off x="6993360" y="135000"/>
            <a:ext cx="6289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r>
              <a:rPr b="1" lang="en-US" sz="3600" spc="-1" strike="noStrike">
                <a:solidFill>
                  <a:srgbClr val="000000"/>
                </a:solidFill>
                <a:latin typeface="Calibri"/>
              </a:rPr>
              <a:t>S2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13"/>
          <p:cNvSpPr/>
          <p:nvPr/>
        </p:nvSpPr>
        <p:spPr>
          <a:xfrm>
            <a:off x="519480" y="673200"/>
            <a:ext cx="6289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r>
              <a:rPr b="1" lang="en-US" sz="3600" spc="-1" strike="noStrike">
                <a:solidFill>
                  <a:srgbClr val="000000"/>
                </a:solidFill>
                <a:latin typeface="Calibri"/>
              </a:rPr>
              <a:t>S1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15"/>
          <p:cNvSpPr/>
          <p:nvPr/>
        </p:nvSpPr>
        <p:spPr>
          <a:xfrm>
            <a:off x="7167600" y="4354560"/>
            <a:ext cx="44038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</a:rPr>
              <a:t>Pro-differentiative edge network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14"/>
          <p:cNvSpPr/>
          <p:nvPr/>
        </p:nvSpPr>
        <p:spPr>
          <a:xfrm>
            <a:off x="496800" y="5809320"/>
            <a:ext cx="6099120" cy="82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</a:rPr>
              <a:t>Perturbation network of significant regulatory edges based on Matrix RNAi data.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10"/>
          <p:cNvSpPr/>
          <p:nvPr/>
        </p:nvSpPr>
        <p:spPr>
          <a:xfrm>
            <a:off x="940320" y="8183520"/>
            <a:ext cx="46080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1" lang="en-US" sz="3600" spc="-1" strike="noStrike">
                <a:solidFill>
                  <a:srgbClr val="000000"/>
                </a:solidFill>
                <a:latin typeface="Calibri"/>
              </a:rPr>
              <a:t>Perturbation networks 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テキスト ボックス 17"/>
          <p:cNvSpPr/>
          <p:nvPr/>
        </p:nvSpPr>
        <p:spPr>
          <a:xfrm>
            <a:off x="115560" y="12600"/>
            <a:ext cx="27518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  <a:ea typeface="ヒラギノ角ゴ ProN"/>
              </a:rPr>
              <a:t>Additional data file 7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9-01T02:11:45Z</dcterms:created>
  <dc:creator>外丸 靖浩</dc:creator>
  <dc:description/>
  <dc:language>en-US</dc:language>
  <cp:lastModifiedBy>外丸 靖浩</cp:lastModifiedBy>
  <dcterms:modified xsi:type="dcterms:W3CDTF">2009-10-23T09:00:14Z</dcterms:modified>
  <cp:revision>9</cp:revision>
  <dc:subject/>
  <dc:title>スライド 1</dc:title>
</cp:coreProperties>
</file>